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notesSlides/notesSlide1.xml" ContentType="application/vnd.openxmlformats-officedocument.presentationml.notesSlide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327" r:id="rId2"/>
    <p:sldId id="273" r:id="rId3"/>
    <p:sldId id="330" r:id="rId4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2928">
          <p15:clr>
            <a:srgbClr val="A4A3A4"/>
          </p15:clr>
        </p15:guide>
        <p15:guide id="2" pos="2208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574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1985"/>
    <p:restoredTop sz="50000" autoAdjust="0"/>
  </p:normalViewPr>
  <p:slideViewPr>
    <p:cSldViewPr snapToGrid="0" snapToObjects="1">
      <p:cViewPr varScale="1">
        <p:scale>
          <a:sx n="88" d="100"/>
          <a:sy n="88" d="100"/>
        </p:scale>
        <p:origin x="-3162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notesViewPr>
    <p:cSldViewPr snapToGrid="0" snapToObjects="1">
      <p:cViewPr varScale="1">
        <p:scale>
          <a:sx n="78" d="100"/>
          <a:sy n="78" d="100"/>
        </p:scale>
        <p:origin x="-2928" y="-102"/>
      </p:cViewPr>
      <p:guideLst>
        <p:guide orient="horz" pos="2928"/>
        <p:guide pos="2208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ancydu:Documents:Dropbox:Nancy's%20Documents:manuscripts:Manuscript%206%20RHAMM%20EGFR:Figures:20130801%20Human%20Tumor%20Samples%20summary%20graph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ancydu:Documents:Dropbox:Nancy's%20Documents:manuscripts:Manuscript%206%20RHAMM%20EGFR:Figures:20130801%20Human%20Tumor%20Samples%20summary%20graph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ancydu:Documents:Dropbox:Nancy's%20Documents:manuscripts:Manuscript%206%20RHAMM%20EGFR:Figures:20130801%20Human%20Tumor%20Samples%20summary%20graph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ancydu:Box%20Sync:Document%20on%20box:manuscripts:Manuscript%2006%20RHAMM%20PanNET:8%20Molecular%20Cancer:Dunrui%2020190718:EGFRRHAMMpanCorrTCGA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ancydu:Box%20Sync:Document%20on%20box:manuscripts:Manuscript%2006%20RHAMM%20PanNET:8%20Molecular%20Cancer:Dunrui%2020190718:EGFRRHAMMpanCorrTCG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6A55"/>
            </a:solidFill>
            <a:ln>
              <a:solidFill>
                <a:srgbClr val="FF6600"/>
              </a:solidFill>
            </a:ln>
          </c:spPr>
          <c:invertIfNegative val="0"/>
          <c:val>
            <c:numRef>
              <c:f>'20160506'!$F$5:$F$16</c:f>
              <c:numCache>
                <c:formatCode>General</c:formatCode>
                <c:ptCount val="12"/>
                <c:pt idx="0">
                  <c:v>0.67495511334253799</c:v>
                </c:pt>
                <c:pt idx="1">
                  <c:v>0.741778458794631</c:v>
                </c:pt>
                <c:pt idx="2">
                  <c:v>0.84074197021916397</c:v>
                </c:pt>
                <c:pt idx="3">
                  <c:v>1.007521412379951</c:v>
                </c:pt>
                <c:pt idx="4">
                  <c:v>1.77353415121643</c:v>
                </c:pt>
                <c:pt idx="5">
                  <c:v>4.1088025416360736</c:v>
                </c:pt>
                <c:pt idx="6">
                  <c:v>4.1872088794182236</c:v>
                </c:pt>
                <c:pt idx="7">
                  <c:v>5.183867064902044</c:v>
                </c:pt>
                <c:pt idx="8">
                  <c:v>8.2755514146251006</c:v>
                </c:pt>
                <c:pt idx="9">
                  <c:v>4.2051301250562334</c:v>
                </c:pt>
                <c:pt idx="10">
                  <c:v>5.532933390072909</c:v>
                </c:pt>
                <c:pt idx="11">
                  <c:v>8.171990347467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A8B-4388-8F15-629778351C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6987008"/>
        <c:axId val="136988544"/>
      </c:barChart>
      <c:catAx>
        <c:axId val="1369870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Arial"/>
              </a:defRPr>
            </a:pPr>
            <a:endParaRPr lang="en-US"/>
          </a:p>
        </c:txPr>
        <c:crossAx val="136988544"/>
        <c:crosses val="autoZero"/>
        <c:auto val="1"/>
        <c:lblAlgn val="ctr"/>
        <c:lblOffset val="100"/>
        <c:noMultiLvlLbl val="0"/>
      </c:catAx>
      <c:valAx>
        <c:axId val="136988544"/>
        <c:scaling>
          <c:orientation val="minMax"/>
          <c:max val="9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Arial"/>
              </a:defRPr>
            </a:pPr>
            <a:endParaRPr lang="en-US"/>
          </a:p>
        </c:txPr>
        <c:crossAx val="1369870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2">
                <a:lumMod val="60000"/>
                <a:lumOff val="40000"/>
              </a:schemeClr>
            </a:solidFill>
          </c:spPr>
          <c:invertIfNegative val="0"/>
          <c:val>
            <c:numRef>
              <c:f>'20160506'!$D$5:$D$16</c:f>
              <c:numCache>
                <c:formatCode>General</c:formatCode>
                <c:ptCount val="12"/>
                <c:pt idx="0">
                  <c:v>0.121484879518155</c:v>
                </c:pt>
                <c:pt idx="1">
                  <c:v>0.13611913350493801</c:v>
                </c:pt>
                <c:pt idx="2">
                  <c:v>0.84633432419852905</c:v>
                </c:pt>
                <c:pt idx="3">
                  <c:v>0.20113736234512999</c:v>
                </c:pt>
                <c:pt idx="4">
                  <c:v>0.117169510597135</c:v>
                </c:pt>
                <c:pt idx="5">
                  <c:v>1.711706678743963</c:v>
                </c:pt>
                <c:pt idx="6">
                  <c:v>1.412602337477062</c:v>
                </c:pt>
                <c:pt idx="7">
                  <c:v>0.67486580278028596</c:v>
                </c:pt>
                <c:pt idx="8">
                  <c:v>9.2910091265071701E-2</c:v>
                </c:pt>
                <c:pt idx="9">
                  <c:v>0.13021983413287</c:v>
                </c:pt>
                <c:pt idx="10">
                  <c:v>2.087462897727665</c:v>
                </c:pt>
                <c:pt idx="11">
                  <c:v>1.61424176435417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B51-472F-B76A-1DB20802CE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7960448"/>
        <c:axId val="177961984"/>
      </c:barChart>
      <c:catAx>
        <c:axId val="17796044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Arial"/>
              </a:defRPr>
            </a:pPr>
            <a:endParaRPr lang="en-US"/>
          </a:p>
        </c:txPr>
        <c:crossAx val="177961984"/>
        <c:crosses val="autoZero"/>
        <c:auto val="1"/>
        <c:lblAlgn val="ctr"/>
        <c:lblOffset val="100"/>
        <c:noMultiLvlLbl val="0"/>
      </c:catAx>
      <c:valAx>
        <c:axId val="177961984"/>
        <c:scaling>
          <c:orientation val="minMax"/>
          <c:max val="9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Arial"/>
              </a:defRPr>
            </a:pPr>
            <a:endParaRPr lang="en-US"/>
          </a:p>
        </c:txPr>
        <c:crossAx val="177960448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7976832"/>
        <c:axId val="177978368"/>
      </c:barChart>
      <c:catAx>
        <c:axId val="17797683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Arial"/>
              </a:defRPr>
            </a:pPr>
            <a:endParaRPr lang="en-US"/>
          </a:p>
        </c:txPr>
        <c:crossAx val="177978368"/>
        <c:crosses val="autoZero"/>
        <c:auto val="1"/>
        <c:lblAlgn val="ctr"/>
        <c:lblOffset val="100"/>
        <c:noMultiLvlLbl val="0"/>
      </c:catAx>
      <c:valAx>
        <c:axId val="177978368"/>
        <c:scaling>
          <c:orientation val="minMax"/>
          <c:max val="9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 i="0">
                <a:latin typeface="Arial"/>
              </a:defRPr>
            </a:pPr>
            <a:endParaRPr lang="en-US"/>
          </a:p>
        </c:txPr>
        <c:crossAx val="17797683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EGFR!$C$1</c:f>
              <c:strCache>
                <c:ptCount val="1"/>
                <c:pt idx="0">
                  <c:v>RHAMM BETA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EGFR!$B$2:$B$129</c:f>
              <c:numCache>
                <c:formatCode>General</c:formatCode>
                <c:ptCount val="128"/>
                <c:pt idx="0">
                  <c:v>28.4495</c:v>
                </c:pt>
                <c:pt idx="1">
                  <c:v>89.956900000000005</c:v>
                </c:pt>
                <c:pt idx="2">
                  <c:v>121.791</c:v>
                </c:pt>
                <c:pt idx="3">
                  <c:v>123.861</c:v>
                </c:pt>
                <c:pt idx="4">
                  <c:v>126.063</c:v>
                </c:pt>
                <c:pt idx="5">
                  <c:v>128.703</c:v>
                </c:pt>
                <c:pt idx="6">
                  <c:v>130.25200000000001</c:v>
                </c:pt>
                <c:pt idx="7">
                  <c:v>164.589</c:v>
                </c:pt>
                <c:pt idx="8">
                  <c:v>192.02500000000001</c:v>
                </c:pt>
                <c:pt idx="9">
                  <c:v>192.22900000000001</c:v>
                </c:pt>
                <c:pt idx="10">
                  <c:v>201.84200000000001</c:v>
                </c:pt>
                <c:pt idx="11">
                  <c:v>209.703</c:v>
                </c:pt>
                <c:pt idx="12">
                  <c:v>233.23400000000001</c:v>
                </c:pt>
                <c:pt idx="13">
                  <c:v>258.19299999999998</c:v>
                </c:pt>
                <c:pt idx="14">
                  <c:v>260.99499999999921</c:v>
                </c:pt>
                <c:pt idx="15">
                  <c:v>266.11599999999999</c:v>
                </c:pt>
                <c:pt idx="16">
                  <c:v>275.02699999999999</c:v>
                </c:pt>
                <c:pt idx="17">
                  <c:v>313.78300000000002</c:v>
                </c:pt>
                <c:pt idx="18">
                  <c:v>316.98200000000003</c:v>
                </c:pt>
                <c:pt idx="19">
                  <c:v>319.55200000000002</c:v>
                </c:pt>
                <c:pt idx="20">
                  <c:v>327.60599999999999</c:v>
                </c:pt>
                <c:pt idx="21">
                  <c:v>338.041</c:v>
                </c:pt>
                <c:pt idx="22">
                  <c:v>343.21499999999997</c:v>
                </c:pt>
                <c:pt idx="23">
                  <c:v>346.65699999999998</c:v>
                </c:pt>
                <c:pt idx="24">
                  <c:v>366.42799999999892</c:v>
                </c:pt>
                <c:pt idx="25">
                  <c:v>369.399</c:v>
                </c:pt>
                <c:pt idx="26">
                  <c:v>370.58699999999999</c:v>
                </c:pt>
                <c:pt idx="27">
                  <c:v>395.96199999999999</c:v>
                </c:pt>
                <c:pt idx="28">
                  <c:v>403.45699999999999</c:v>
                </c:pt>
                <c:pt idx="29">
                  <c:v>406.334</c:v>
                </c:pt>
                <c:pt idx="30">
                  <c:v>419.46300000000002</c:v>
                </c:pt>
                <c:pt idx="31">
                  <c:v>420.01100000000002</c:v>
                </c:pt>
                <c:pt idx="32">
                  <c:v>427.36200000000002</c:v>
                </c:pt>
                <c:pt idx="33">
                  <c:v>434.702</c:v>
                </c:pt>
                <c:pt idx="34">
                  <c:v>443.59</c:v>
                </c:pt>
                <c:pt idx="35">
                  <c:v>444.32600000000002</c:v>
                </c:pt>
                <c:pt idx="36">
                  <c:v>455.85</c:v>
                </c:pt>
                <c:pt idx="37">
                  <c:v>473.99400000000003</c:v>
                </c:pt>
                <c:pt idx="38">
                  <c:v>484.95499999999998</c:v>
                </c:pt>
                <c:pt idx="39">
                  <c:v>486.01900000000001</c:v>
                </c:pt>
                <c:pt idx="40">
                  <c:v>488.91899999999998</c:v>
                </c:pt>
                <c:pt idx="41">
                  <c:v>488.98200000000003</c:v>
                </c:pt>
                <c:pt idx="42">
                  <c:v>495.8</c:v>
                </c:pt>
                <c:pt idx="43">
                  <c:v>505.089</c:v>
                </c:pt>
                <c:pt idx="44">
                  <c:v>512.37099999999998</c:v>
                </c:pt>
                <c:pt idx="45">
                  <c:v>515.81999999999937</c:v>
                </c:pt>
                <c:pt idx="46">
                  <c:v>515.88099999999997</c:v>
                </c:pt>
                <c:pt idx="47">
                  <c:v>537.49199999999996</c:v>
                </c:pt>
                <c:pt idx="48">
                  <c:v>547.37900000000002</c:v>
                </c:pt>
                <c:pt idx="49">
                  <c:v>551.08000000000004</c:v>
                </c:pt>
                <c:pt idx="50">
                  <c:v>557.35399999999936</c:v>
                </c:pt>
                <c:pt idx="51">
                  <c:v>558.56699999999739</c:v>
                </c:pt>
                <c:pt idx="52">
                  <c:v>584.24300000000005</c:v>
                </c:pt>
                <c:pt idx="53">
                  <c:v>584.55999999999938</c:v>
                </c:pt>
                <c:pt idx="54">
                  <c:v>610.41800000000001</c:v>
                </c:pt>
                <c:pt idx="55">
                  <c:v>630.30699999999786</c:v>
                </c:pt>
                <c:pt idx="56">
                  <c:v>631.92999999999938</c:v>
                </c:pt>
                <c:pt idx="57">
                  <c:v>635.76599999999996</c:v>
                </c:pt>
                <c:pt idx="58">
                  <c:v>640.19200000000001</c:v>
                </c:pt>
                <c:pt idx="59">
                  <c:v>648.95399999999995</c:v>
                </c:pt>
                <c:pt idx="60">
                  <c:v>657.31199999999785</c:v>
                </c:pt>
                <c:pt idx="61">
                  <c:v>672.34099999999739</c:v>
                </c:pt>
                <c:pt idx="62">
                  <c:v>677.41600000000005</c:v>
                </c:pt>
                <c:pt idx="63">
                  <c:v>678.07899999999995</c:v>
                </c:pt>
                <c:pt idx="64">
                  <c:v>679.78800000000001</c:v>
                </c:pt>
                <c:pt idx="65">
                  <c:v>700.38</c:v>
                </c:pt>
                <c:pt idx="66">
                  <c:v>701.99900000000002</c:v>
                </c:pt>
                <c:pt idx="67">
                  <c:v>704.01</c:v>
                </c:pt>
                <c:pt idx="68">
                  <c:v>707.76599999999996</c:v>
                </c:pt>
                <c:pt idx="69">
                  <c:v>720.28099999999995</c:v>
                </c:pt>
                <c:pt idx="70">
                  <c:v>734.97500000000002</c:v>
                </c:pt>
                <c:pt idx="71">
                  <c:v>737.68700000000001</c:v>
                </c:pt>
                <c:pt idx="72">
                  <c:v>747.92399999999998</c:v>
                </c:pt>
                <c:pt idx="73">
                  <c:v>752.298</c:v>
                </c:pt>
                <c:pt idx="74">
                  <c:v>755.51400000000001</c:v>
                </c:pt>
                <c:pt idx="75">
                  <c:v>756.45599999999786</c:v>
                </c:pt>
                <c:pt idx="76">
                  <c:v>759.50199999999995</c:v>
                </c:pt>
                <c:pt idx="77">
                  <c:v>760.74199999999996</c:v>
                </c:pt>
                <c:pt idx="78">
                  <c:v>779.471</c:v>
                </c:pt>
                <c:pt idx="79">
                  <c:v>782.22199999999998</c:v>
                </c:pt>
                <c:pt idx="80">
                  <c:v>787.29100000000005</c:v>
                </c:pt>
                <c:pt idx="81">
                  <c:v>815.96599999999739</c:v>
                </c:pt>
                <c:pt idx="82">
                  <c:v>878.05499999999938</c:v>
                </c:pt>
                <c:pt idx="83">
                  <c:v>905.61900000000003</c:v>
                </c:pt>
                <c:pt idx="84">
                  <c:v>907.99</c:v>
                </c:pt>
                <c:pt idx="85">
                  <c:v>912.37800000000004</c:v>
                </c:pt>
                <c:pt idx="86">
                  <c:v>934.65800000000002</c:v>
                </c:pt>
                <c:pt idx="87">
                  <c:v>943.34999999999786</c:v>
                </c:pt>
                <c:pt idx="88">
                  <c:v>944.14699999999937</c:v>
                </c:pt>
                <c:pt idx="89">
                  <c:v>949.18100000000004</c:v>
                </c:pt>
                <c:pt idx="90">
                  <c:v>951.726</c:v>
                </c:pt>
                <c:pt idx="91">
                  <c:v>958.12599999999998</c:v>
                </c:pt>
                <c:pt idx="92">
                  <c:v>969.221</c:v>
                </c:pt>
                <c:pt idx="93">
                  <c:v>980.32399999999996</c:v>
                </c:pt>
                <c:pt idx="94">
                  <c:v>986.38499999999999</c:v>
                </c:pt>
                <c:pt idx="95">
                  <c:v>988.39</c:v>
                </c:pt>
                <c:pt idx="96">
                  <c:v>996.38300000000004</c:v>
                </c:pt>
                <c:pt idx="97">
                  <c:v>1005.15</c:v>
                </c:pt>
                <c:pt idx="98">
                  <c:v>1013.57</c:v>
                </c:pt>
                <c:pt idx="99">
                  <c:v>1024.92</c:v>
                </c:pt>
                <c:pt idx="100">
                  <c:v>1030.6500000000001</c:v>
                </c:pt>
                <c:pt idx="101">
                  <c:v>1039.4000000000001</c:v>
                </c:pt>
                <c:pt idx="102">
                  <c:v>1056.93</c:v>
                </c:pt>
                <c:pt idx="103">
                  <c:v>1057.3</c:v>
                </c:pt>
                <c:pt idx="104">
                  <c:v>1061.72</c:v>
                </c:pt>
                <c:pt idx="105">
                  <c:v>1094.56</c:v>
                </c:pt>
                <c:pt idx="106">
                  <c:v>1128.4000000000001</c:v>
                </c:pt>
                <c:pt idx="107">
                  <c:v>1197.4000000000001</c:v>
                </c:pt>
                <c:pt idx="108">
                  <c:v>1203.28</c:v>
                </c:pt>
                <c:pt idx="109">
                  <c:v>1206.28</c:v>
                </c:pt>
                <c:pt idx="110">
                  <c:v>1223.6600000000001</c:v>
                </c:pt>
                <c:pt idx="111">
                  <c:v>1234.8900000000001</c:v>
                </c:pt>
                <c:pt idx="112">
                  <c:v>1309.25</c:v>
                </c:pt>
                <c:pt idx="113">
                  <c:v>1338.81</c:v>
                </c:pt>
                <c:pt idx="114">
                  <c:v>1357.22</c:v>
                </c:pt>
                <c:pt idx="115">
                  <c:v>1402.36</c:v>
                </c:pt>
                <c:pt idx="116">
                  <c:v>1427.83</c:v>
                </c:pt>
                <c:pt idx="117">
                  <c:v>1439.64</c:v>
                </c:pt>
                <c:pt idx="118">
                  <c:v>1474.24</c:v>
                </c:pt>
                <c:pt idx="119">
                  <c:v>1516.61</c:v>
                </c:pt>
                <c:pt idx="120">
                  <c:v>1533.04</c:v>
                </c:pt>
                <c:pt idx="121">
                  <c:v>1666.46</c:v>
                </c:pt>
                <c:pt idx="122">
                  <c:v>1695.82</c:v>
                </c:pt>
                <c:pt idx="123">
                  <c:v>1696.19</c:v>
                </c:pt>
                <c:pt idx="124">
                  <c:v>1724.53</c:v>
                </c:pt>
                <c:pt idx="125">
                  <c:v>2193.4</c:v>
                </c:pt>
                <c:pt idx="126">
                  <c:v>2421.7199999999998</c:v>
                </c:pt>
                <c:pt idx="127">
                  <c:v>2788.71</c:v>
                </c:pt>
              </c:numCache>
            </c:numRef>
          </c:xVal>
          <c:yVal>
            <c:numRef>
              <c:f>EGFR!$C$2:$C$129</c:f>
              <c:numCache>
                <c:formatCode>General</c:formatCode>
                <c:ptCount val="128"/>
                <c:pt idx="0">
                  <c:v>0</c:v>
                </c:pt>
                <c:pt idx="1">
                  <c:v>32.490099999999998</c:v>
                </c:pt>
                <c:pt idx="2">
                  <c:v>34.422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2.6297</c:v>
                </c:pt>
                <c:pt idx="7">
                  <c:v>15.2196</c:v>
                </c:pt>
                <c:pt idx="8">
                  <c:v>0</c:v>
                </c:pt>
                <c:pt idx="9">
                  <c:v>78.239000000000004</c:v>
                </c:pt>
                <c:pt idx="10">
                  <c:v>348.84399999999999</c:v>
                </c:pt>
                <c:pt idx="11">
                  <c:v>0</c:v>
                </c:pt>
                <c:pt idx="12">
                  <c:v>93.02079999999998</c:v>
                </c:pt>
                <c:pt idx="13">
                  <c:v>10.124499999999999</c:v>
                </c:pt>
                <c:pt idx="14">
                  <c:v>63.896000000000001</c:v>
                </c:pt>
                <c:pt idx="15">
                  <c:v>0</c:v>
                </c:pt>
                <c:pt idx="16">
                  <c:v>0</c:v>
                </c:pt>
                <c:pt idx="17">
                  <c:v>21.556799999999999</c:v>
                </c:pt>
                <c:pt idx="18">
                  <c:v>35.156199999999998</c:v>
                </c:pt>
                <c:pt idx="19">
                  <c:v>10.239599999999999</c:v>
                </c:pt>
                <c:pt idx="20">
                  <c:v>78.774000000000001</c:v>
                </c:pt>
                <c:pt idx="21">
                  <c:v>8.7273999999999994</c:v>
                </c:pt>
                <c:pt idx="22">
                  <c:v>9.1686999999999994</c:v>
                </c:pt>
                <c:pt idx="23">
                  <c:v>138.47900000000001</c:v>
                </c:pt>
                <c:pt idx="24">
                  <c:v>67.817599999999999</c:v>
                </c:pt>
                <c:pt idx="25">
                  <c:v>76.408199999999994</c:v>
                </c:pt>
                <c:pt idx="26">
                  <c:v>280.649</c:v>
                </c:pt>
                <c:pt idx="27">
                  <c:v>15.032299999999999</c:v>
                </c:pt>
                <c:pt idx="28">
                  <c:v>0</c:v>
                </c:pt>
                <c:pt idx="29">
                  <c:v>125.935</c:v>
                </c:pt>
                <c:pt idx="30">
                  <c:v>90.766199999999998</c:v>
                </c:pt>
                <c:pt idx="31">
                  <c:v>9.9604999999999997</c:v>
                </c:pt>
                <c:pt idx="32">
                  <c:v>68.769599999999997</c:v>
                </c:pt>
                <c:pt idx="33">
                  <c:v>26.783000000000001</c:v>
                </c:pt>
                <c:pt idx="34">
                  <c:v>24.065799999999999</c:v>
                </c:pt>
                <c:pt idx="35">
                  <c:v>68.462299999999999</c:v>
                </c:pt>
                <c:pt idx="36">
                  <c:v>132.85499999999999</c:v>
                </c:pt>
                <c:pt idx="37">
                  <c:v>131.48599999999999</c:v>
                </c:pt>
                <c:pt idx="38">
                  <c:v>158.131</c:v>
                </c:pt>
                <c:pt idx="39">
                  <c:v>55.136000000000003</c:v>
                </c:pt>
                <c:pt idx="40">
                  <c:v>108.43</c:v>
                </c:pt>
                <c:pt idx="41">
                  <c:v>160.10300000000001</c:v>
                </c:pt>
                <c:pt idx="42">
                  <c:v>120.643</c:v>
                </c:pt>
                <c:pt idx="43">
                  <c:v>33.542200000000001</c:v>
                </c:pt>
                <c:pt idx="44">
                  <c:v>175.06100000000001</c:v>
                </c:pt>
                <c:pt idx="45">
                  <c:v>39.080100000000002</c:v>
                </c:pt>
                <c:pt idx="46">
                  <c:v>75.448800000000006</c:v>
                </c:pt>
                <c:pt idx="47">
                  <c:v>90.516800000000003</c:v>
                </c:pt>
                <c:pt idx="48">
                  <c:v>137.53100000000001</c:v>
                </c:pt>
                <c:pt idx="49">
                  <c:v>167.38900000000001</c:v>
                </c:pt>
                <c:pt idx="50">
                  <c:v>175.423</c:v>
                </c:pt>
                <c:pt idx="51">
                  <c:v>0</c:v>
                </c:pt>
                <c:pt idx="52">
                  <c:v>81.671699999999987</c:v>
                </c:pt>
                <c:pt idx="53">
                  <c:v>0</c:v>
                </c:pt>
                <c:pt idx="54">
                  <c:v>31.509599999999999</c:v>
                </c:pt>
                <c:pt idx="55">
                  <c:v>104.42400000000001</c:v>
                </c:pt>
                <c:pt idx="56">
                  <c:v>116.886</c:v>
                </c:pt>
                <c:pt idx="57">
                  <c:v>0</c:v>
                </c:pt>
                <c:pt idx="58">
                  <c:v>141.83699999999999</c:v>
                </c:pt>
                <c:pt idx="59">
                  <c:v>111.64100000000001</c:v>
                </c:pt>
                <c:pt idx="60">
                  <c:v>0</c:v>
                </c:pt>
                <c:pt idx="61">
                  <c:v>210.62200000000001</c:v>
                </c:pt>
                <c:pt idx="62">
                  <c:v>115.01600000000001</c:v>
                </c:pt>
                <c:pt idx="63">
                  <c:v>17.6004</c:v>
                </c:pt>
                <c:pt idx="64">
                  <c:v>32.8307</c:v>
                </c:pt>
                <c:pt idx="65">
                  <c:v>57.792499999999997</c:v>
                </c:pt>
                <c:pt idx="66">
                  <c:v>118.166</c:v>
                </c:pt>
                <c:pt idx="67">
                  <c:v>93.498800000000003</c:v>
                </c:pt>
                <c:pt idx="68">
                  <c:v>38.740099999999998</c:v>
                </c:pt>
                <c:pt idx="69">
                  <c:v>15.951499999999999</c:v>
                </c:pt>
                <c:pt idx="70">
                  <c:v>9.8702000000000005</c:v>
                </c:pt>
                <c:pt idx="71">
                  <c:v>196.09299999999999</c:v>
                </c:pt>
                <c:pt idx="72">
                  <c:v>167.05799999999999</c:v>
                </c:pt>
                <c:pt idx="73">
                  <c:v>94.708699999999993</c:v>
                </c:pt>
                <c:pt idx="74">
                  <c:v>240.38</c:v>
                </c:pt>
                <c:pt idx="75">
                  <c:v>0.73680000000000001</c:v>
                </c:pt>
                <c:pt idx="76">
                  <c:v>67.236400000000003</c:v>
                </c:pt>
                <c:pt idx="77">
                  <c:v>13.8057</c:v>
                </c:pt>
                <c:pt idx="78">
                  <c:v>69.483900000000006</c:v>
                </c:pt>
                <c:pt idx="79">
                  <c:v>181.97900000000001</c:v>
                </c:pt>
                <c:pt idx="80">
                  <c:v>256.75</c:v>
                </c:pt>
                <c:pt idx="81">
                  <c:v>98.420299999999997</c:v>
                </c:pt>
                <c:pt idx="82">
                  <c:v>97.259799999999998</c:v>
                </c:pt>
                <c:pt idx="83">
                  <c:v>0</c:v>
                </c:pt>
                <c:pt idx="84">
                  <c:v>158.91499999999999</c:v>
                </c:pt>
                <c:pt idx="85">
                  <c:v>40.484699999999997</c:v>
                </c:pt>
                <c:pt idx="86">
                  <c:v>174.36500000000001</c:v>
                </c:pt>
                <c:pt idx="87">
                  <c:v>122.128</c:v>
                </c:pt>
                <c:pt idx="88">
                  <c:v>367.23599999999891</c:v>
                </c:pt>
                <c:pt idx="89">
                  <c:v>69.3292</c:v>
                </c:pt>
                <c:pt idx="90">
                  <c:v>115.642</c:v>
                </c:pt>
                <c:pt idx="91">
                  <c:v>85.435599999999994</c:v>
                </c:pt>
                <c:pt idx="92">
                  <c:v>65.27979999999998</c:v>
                </c:pt>
                <c:pt idx="93">
                  <c:v>34.078899999999997</c:v>
                </c:pt>
                <c:pt idx="94">
                  <c:v>58.199599999999997</c:v>
                </c:pt>
                <c:pt idx="95">
                  <c:v>96.8917</c:v>
                </c:pt>
                <c:pt idx="96">
                  <c:v>202.215</c:v>
                </c:pt>
                <c:pt idx="97">
                  <c:v>153.51499999999999</c:v>
                </c:pt>
                <c:pt idx="98">
                  <c:v>132.11699999999999</c:v>
                </c:pt>
                <c:pt idx="99">
                  <c:v>43.9377</c:v>
                </c:pt>
                <c:pt idx="100">
                  <c:v>196.70099999999999</c:v>
                </c:pt>
                <c:pt idx="101">
                  <c:v>132.57499999999999</c:v>
                </c:pt>
                <c:pt idx="102">
                  <c:v>35.314399999999999</c:v>
                </c:pt>
                <c:pt idx="103">
                  <c:v>289.03899999999999</c:v>
                </c:pt>
                <c:pt idx="104">
                  <c:v>13.078799999999999</c:v>
                </c:pt>
                <c:pt idx="105">
                  <c:v>63.95</c:v>
                </c:pt>
                <c:pt idx="106">
                  <c:v>243.977</c:v>
                </c:pt>
                <c:pt idx="107">
                  <c:v>80.155199999999979</c:v>
                </c:pt>
                <c:pt idx="108">
                  <c:v>93.0792</c:v>
                </c:pt>
                <c:pt idx="109">
                  <c:v>170.99</c:v>
                </c:pt>
                <c:pt idx="110">
                  <c:v>88.103999999999999</c:v>
                </c:pt>
                <c:pt idx="111">
                  <c:v>9.2085000000000008</c:v>
                </c:pt>
                <c:pt idx="112">
                  <c:v>0</c:v>
                </c:pt>
                <c:pt idx="113">
                  <c:v>272.56700000000001</c:v>
                </c:pt>
                <c:pt idx="114">
                  <c:v>82.3429</c:v>
                </c:pt>
                <c:pt idx="115">
                  <c:v>158.941</c:v>
                </c:pt>
                <c:pt idx="116">
                  <c:v>225.28700000000001</c:v>
                </c:pt>
                <c:pt idx="117">
                  <c:v>223.964</c:v>
                </c:pt>
                <c:pt idx="118">
                  <c:v>330.92700000000002</c:v>
                </c:pt>
                <c:pt idx="119">
                  <c:v>121.94799999999999</c:v>
                </c:pt>
                <c:pt idx="120">
                  <c:v>73.831699999999998</c:v>
                </c:pt>
                <c:pt idx="121">
                  <c:v>502.99700000000001</c:v>
                </c:pt>
                <c:pt idx="122">
                  <c:v>71.8249</c:v>
                </c:pt>
                <c:pt idx="123">
                  <c:v>324.875</c:v>
                </c:pt>
                <c:pt idx="124">
                  <c:v>9.0700000000000003E-2</c:v>
                </c:pt>
                <c:pt idx="125">
                  <c:v>431.42299999999892</c:v>
                </c:pt>
                <c:pt idx="126">
                  <c:v>246.38</c:v>
                </c:pt>
                <c:pt idx="127">
                  <c:v>144.86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CA1-D346-9807-73194A3BAF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6614912"/>
        <c:axId val="186328960"/>
      </c:scatterChart>
      <c:valAx>
        <c:axId val="1266149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1" u="none" strike="noStrike" kern="1200" baseline="0">
                    <a:solidFill>
                      <a:srgbClr val="000000"/>
                    </a:solidFill>
                    <a:latin typeface="Arial"/>
                    <a:ea typeface="+mn-ea"/>
                    <a:cs typeface="Arial"/>
                  </a:defRPr>
                </a:pPr>
                <a:r>
                  <a:rPr lang="en-US" sz="1200" b="0" i="1">
                    <a:solidFill>
                      <a:srgbClr val="000000"/>
                    </a:solidFill>
                    <a:latin typeface="Arial"/>
                    <a:cs typeface="Arial"/>
                  </a:rPr>
                  <a:t>EGFR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rgbClr val="000000"/>
                </a:solidFill>
                <a:latin typeface="Arial"/>
                <a:ea typeface="+mn-ea"/>
                <a:cs typeface="Arial"/>
              </a:defRPr>
            </a:pPr>
            <a:endParaRPr lang="en-US"/>
          </a:p>
        </c:txPr>
        <c:crossAx val="186328960"/>
        <c:crosses val="autoZero"/>
        <c:crossBetween val="midCat"/>
      </c:valAx>
      <c:valAx>
        <c:axId val="1863289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1" u="none" strike="noStrike" kern="1200" baseline="0">
                    <a:solidFill>
                      <a:srgbClr val="000000"/>
                    </a:solidFill>
                    <a:latin typeface="Arial"/>
                    <a:ea typeface="+mn-ea"/>
                    <a:cs typeface="Arial"/>
                  </a:defRPr>
                </a:pPr>
                <a:r>
                  <a:rPr lang="en-US" sz="1200" b="0" i="1">
                    <a:solidFill>
                      <a:srgbClr val="000000"/>
                    </a:solidFill>
                    <a:latin typeface="Arial"/>
                    <a:cs typeface="Arial"/>
                  </a:rPr>
                  <a:t>RHAMM</a:t>
                </a:r>
                <a:r>
                  <a:rPr lang="en-US" sz="1200" b="0" i="1" baseline="30000">
                    <a:solidFill>
                      <a:srgbClr val="000000"/>
                    </a:solidFill>
                    <a:latin typeface="Arial"/>
                    <a:cs typeface="Arial"/>
                  </a:rPr>
                  <a:t>B</a:t>
                </a:r>
                <a:endParaRPr lang="en-US" b="0" i="1" baseline="30000">
                  <a:solidFill>
                    <a:srgbClr val="000000"/>
                  </a:solidFill>
                  <a:latin typeface="Arial"/>
                  <a:cs typeface="Arial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/>
                <a:ea typeface="+mn-ea"/>
                <a:cs typeface="Arial"/>
              </a:defRPr>
            </a:pPr>
            <a:endParaRPr lang="en-US"/>
          </a:p>
        </c:txPr>
        <c:crossAx val="1266149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EGFR!$B$1:$B$129</c:f>
              <c:strCache>
                <c:ptCount val="129"/>
                <c:pt idx="0">
                  <c:v>EGFR</c:v>
                </c:pt>
                <c:pt idx="1">
                  <c:v>28.4495</c:v>
                </c:pt>
                <c:pt idx="2">
                  <c:v>89.9569</c:v>
                </c:pt>
                <c:pt idx="3">
                  <c:v>121.791</c:v>
                </c:pt>
                <c:pt idx="4">
                  <c:v>123.861</c:v>
                </c:pt>
                <c:pt idx="5">
                  <c:v>126.063</c:v>
                </c:pt>
                <c:pt idx="6">
                  <c:v>128.703</c:v>
                </c:pt>
                <c:pt idx="7">
                  <c:v>130.252</c:v>
                </c:pt>
                <c:pt idx="8">
                  <c:v>164.589</c:v>
                </c:pt>
                <c:pt idx="9">
                  <c:v>192.025</c:v>
                </c:pt>
                <c:pt idx="10">
                  <c:v>192.229</c:v>
                </c:pt>
                <c:pt idx="11">
                  <c:v>201.842</c:v>
                </c:pt>
                <c:pt idx="12">
                  <c:v>209.703</c:v>
                </c:pt>
                <c:pt idx="13">
                  <c:v>233.234</c:v>
                </c:pt>
                <c:pt idx="14">
                  <c:v>258.193</c:v>
                </c:pt>
                <c:pt idx="15">
                  <c:v>260.995</c:v>
                </c:pt>
                <c:pt idx="16">
                  <c:v>266.116</c:v>
                </c:pt>
                <c:pt idx="17">
                  <c:v>275.027</c:v>
                </c:pt>
                <c:pt idx="18">
                  <c:v>313.783</c:v>
                </c:pt>
                <c:pt idx="19">
                  <c:v>316.982</c:v>
                </c:pt>
                <c:pt idx="20">
                  <c:v>319.552</c:v>
                </c:pt>
                <c:pt idx="21">
                  <c:v>327.606</c:v>
                </c:pt>
                <c:pt idx="22">
                  <c:v>338.041</c:v>
                </c:pt>
                <c:pt idx="23">
                  <c:v>343.215</c:v>
                </c:pt>
                <c:pt idx="24">
                  <c:v>346.657</c:v>
                </c:pt>
                <c:pt idx="25">
                  <c:v>366.428</c:v>
                </c:pt>
                <c:pt idx="26">
                  <c:v>369.399</c:v>
                </c:pt>
                <c:pt idx="27">
                  <c:v>370.587</c:v>
                </c:pt>
                <c:pt idx="28">
                  <c:v>395.962</c:v>
                </c:pt>
                <c:pt idx="29">
                  <c:v>403.457</c:v>
                </c:pt>
                <c:pt idx="30">
                  <c:v>406.334</c:v>
                </c:pt>
                <c:pt idx="31">
                  <c:v>419.463</c:v>
                </c:pt>
                <c:pt idx="32">
                  <c:v>420.011</c:v>
                </c:pt>
                <c:pt idx="33">
                  <c:v>427.362</c:v>
                </c:pt>
                <c:pt idx="34">
                  <c:v>434.702</c:v>
                </c:pt>
                <c:pt idx="35">
                  <c:v>443.59</c:v>
                </c:pt>
                <c:pt idx="36">
                  <c:v>444.326</c:v>
                </c:pt>
                <c:pt idx="37">
                  <c:v>455.85</c:v>
                </c:pt>
                <c:pt idx="38">
                  <c:v>473.994</c:v>
                </c:pt>
                <c:pt idx="39">
                  <c:v>484.955</c:v>
                </c:pt>
                <c:pt idx="40">
                  <c:v>486.019</c:v>
                </c:pt>
                <c:pt idx="41">
                  <c:v>488.919</c:v>
                </c:pt>
                <c:pt idx="42">
                  <c:v>488.982</c:v>
                </c:pt>
                <c:pt idx="43">
                  <c:v>495.8</c:v>
                </c:pt>
                <c:pt idx="44">
                  <c:v>505.089</c:v>
                </c:pt>
                <c:pt idx="45">
                  <c:v>512.371</c:v>
                </c:pt>
                <c:pt idx="46">
                  <c:v>515.82</c:v>
                </c:pt>
                <c:pt idx="47">
                  <c:v>515.881</c:v>
                </c:pt>
                <c:pt idx="48">
                  <c:v>537.492</c:v>
                </c:pt>
                <c:pt idx="49">
                  <c:v>547.379</c:v>
                </c:pt>
                <c:pt idx="50">
                  <c:v>551.08</c:v>
                </c:pt>
                <c:pt idx="51">
                  <c:v>557.354</c:v>
                </c:pt>
                <c:pt idx="52">
                  <c:v>558.567</c:v>
                </c:pt>
                <c:pt idx="53">
                  <c:v>584.243</c:v>
                </c:pt>
                <c:pt idx="54">
                  <c:v>584.56</c:v>
                </c:pt>
                <c:pt idx="55">
                  <c:v>610.418</c:v>
                </c:pt>
                <c:pt idx="56">
                  <c:v>630.307</c:v>
                </c:pt>
                <c:pt idx="57">
                  <c:v>631.93</c:v>
                </c:pt>
                <c:pt idx="58">
                  <c:v>635.766</c:v>
                </c:pt>
                <c:pt idx="59">
                  <c:v>640.192</c:v>
                </c:pt>
                <c:pt idx="60">
                  <c:v>648.954</c:v>
                </c:pt>
                <c:pt idx="61">
                  <c:v>657.312</c:v>
                </c:pt>
                <c:pt idx="62">
                  <c:v>672.341</c:v>
                </c:pt>
                <c:pt idx="63">
                  <c:v>677.416</c:v>
                </c:pt>
                <c:pt idx="64">
                  <c:v>678.079</c:v>
                </c:pt>
                <c:pt idx="65">
                  <c:v>679.788</c:v>
                </c:pt>
                <c:pt idx="66">
                  <c:v>700.38</c:v>
                </c:pt>
                <c:pt idx="67">
                  <c:v>701.999</c:v>
                </c:pt>
                <c:pt idx="68">
                  <c:v>704.01</c:v>
                </c:pt>
                <c:pt idx="69">
                  <c:v>707.766</c:v>
                </c:pt>
                <c:pt idx="70">
                  <c:v>720.281</c:v>
                </c:pt>
                <c:pt idx="71">
                  <c:v>734.975</c:v>
                </c:pt>
                <c:pt idx="72">
                  <c:v>737.687</c:v>
                </c:pt>
                <c:pt idx="73">
                  <c:v>747.924</c:v>
                </c:pt>
                <c:pt idx="74">
                  <c:v>752.298</c:v>
                </c:pt>
                <c:pt idx="75">
                  <c:v>755.514</c:v>
                </c:pt>
                <c:pt idx="76">
                  <c:v>756.456</c:v>
                </c:pt>
                <c:pt idx="77">
                  <c:v>759.502</c:v>
                </c:pt>
                <c:pt idx="78">
                  <c:v>760.742</c:v>
                </c:pt>
                <c:pt idx="79">
                  <c:v>779.471</c:v>
                </c:pt>
                <c:pt idx="80">
                  <c:v>782.222</c:v>
                </c:pt>
                <c:pt idx="81">
                  <c:v>787.291</c:v>
                </c:pt>
                <c:pt idx="82">
                  <c:v>815.966</c:v>
                </c:pt>
                <c:pt idx="83">
                  <c:v>878.055</c:v>
                </c:pt>
                <c:pt idx="84">
                  <c:v>905.619</c:v>
                </c:pt>
                <c:pt idx="85">
                  <c:v>907.99</c:v>
                </c:pt>
                <c:pt idx="86">
                  <c:v>912.378</c:v>
                </c:pt>
                <c:pt idx="87">
                  <c:v>934.658</c:v>
                </c:pt>
                <c:pt idx="88">
                  <c:v>943.35</c:v>
                </c:pt>
                <c:pt idx="89">
                  <c:v>944.147</c:v>
                </c:pt>
                <c:pt idx="90">
                  <c:v>949.181</c:v>
                </c:pt>
                <c:pt idx="91">
                  <c:v>951.726</c:v>
                </c:pt>
                <c:pt idx="92">
                  <c:v>958.126</c:v>
                </c:pt>
                <c:pt idx="93">
                  <c:v>969.221</c:v>
                </c:pt>
                <c:pt idx="94">
                  <c:v>980.324</c:v>
                </c:pt>
                <c:pt idx="95">
                  <c:v>986.385</c:v>
                </c:pt>
                <c:pt idx="96">
                  <c:v>988.39</c:v>
                </c:pt>
                <c:pt idx="97">
                  <c:v>996.383</c:v>
                </c:pt>
                <c:pt idx="98">
                  <c:v>1005.15</c:v>
                </c:pt>
                <c:pt idx="99">
                  <c:v>1013.57</c:v>
                </c:pt>
                <c:pt idx="100">
                  <c:v>1024.92</c:v>
                </c:pt>
                <c:pt idx="101">
                  <c:v>1030.65</c:v>
                </c:pt>
                <c:pt idx="102">
                  <c:v>1039.4</c:v>
                </c:pt>
                <c:pt idx="103">
                  <c:v>1056.93</c:v>
                </c:pt>
                <c:pt idx="104">
                  <c:v>1057.3</c:v>
                </c:pt>
                <c:pt idx="105">
                  <c:v>1061.72</c:v>
                </c:pt>
                <c:pt idx="106">
                  <c:v>1094.56</c:v>
                </c:pt>
                <c:pt idx="107">
                  <c:v>1128.4</c:v>
                </c:pt>
                <c:pt idx="108">
                  <c:v>1197.4</c:v>
                </c:pt>
                <c:pt idx="109">
                  <c:v>1203.28</c:v>
                </c:pt>
                <c:pt idx="110">
                  <c:v>1206.28</c:v>
                </c:pt>
                <c:pt idx="111">
                  <c:v>1223.66</c:v>
                </c:pt>
                <c:pt idx="112">
                  <c:v>1234.89</c:v>
                </c:pt>
                <c:pt idx="113">
                  <c:v>1309.25</c:v>
                </c:pt>
                <c:pt idx="114">
                  <c:v>1338.81</c:v>
                </c:pt>
                <c:pt idx="115">
                  <c:v>1357.22</c:v>
                </c:pt>
                <c:pt idx="116">
                  <c:v>1402.36</c:v>
                </c:pt>
                <c:pt idx="117">
                  <c:v>1427.83</c:v>
                </c:pt>
                <c:pt idx="118">
                  <c:v>1439.64</c:v>
                </c:pt>
                <c:pt idx="119">
                  <c:v>1474.24</c:v>
                </c:pt>
                <c:pt idx="120">
                  <c:v>1516.61</c:v>
                </c:pt>
                <c:pt idx="121">
                  <c:v>1533.04</c:v>
                </c:pt>
                <c:pt idx="122">
                  <c:v>1666.46</c:v>
                </c:pt>
                <c:pt idx="123">
                  <c:v>1695.82</c:v>
                </c:pt>
                <c:pt idx="124">
                  <c:v>1696.19</c:v>
                </c:pt>
                <c:pt idx="125">
                  <c:v>1724.53</c:v>
                </c:pt>
                <c:pt idx="126">
                  <c:v>2193.4</c:v>
                </c:pt>
                <c:pt idx="127">
                  <c:v>2421.72</c:v>
                </c:pt>
                <c:pt idx="128">
                  <c:v>2788.71</c:v>
                </c:pt>
              </c:strCache>
            </c:strRef>
          </c:xVal>
          <c:yVal>
            <c:numRef>
              <c:f>EGFR!$D$1:$D$129</c:f>
              <c:numCache>
                <c:formatCode>General</c:formatCode>
                <c:ptCount val="12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21.089099999999998</c:v>
                </c:pt>
                <c:pt idx="25">
                  <c:v>86.8232</c:v>
                </c:pt>
                <c:pt idx="26">
                  <c:v>0</c:v>
                </c:pt>
                <c:pt idx="27">
                  <c:v>54.3005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32.053600000000003</c:v>
                </c:pt>
                <c:pt idx="41">
                  <c:v>48.245800000000003</c:v>
                </c:pt>
                <c:pt idx="42">
                  <c:v>0</c:v>
                </c:pt>
                <c:pt idx="43">
                  <c:v>0</c:v>
                </c:pt>
                <c:pt idx="44">
                  <c:v>43.963200000000001</c:v>
                </c:pt>
                <c:pt idx="45">
                  <c:v>61.986600000000003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25.5792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32.451599999999999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40.386000000000003</c:v>
                </c:pt>
                <c:pt idx="77">
                  <c:v>23.3308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34.4741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49.3459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43.7117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27.777999999999999</c:v>
                </c:pt>
                <c:pt idx="103">
                  <c:v>0</c:v>
                </c:pt>
                <c:pt idx="104">
                  <c:v>62.686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28.247900000000001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46.210700000000003</c:v>
                </c:pt>
                <c:pt idx="121">
                  <c:v>0</c:v>
                </c:pt>
                <c:pt idx="122">
                  <c:v>93.818600000000004</c:v>
                </c:pt>
                <c:pt idx="123">
                  <c:v>0</c:v>
                </c:pt>
                <c:pt idx="124">
                  <c:v>0</c:v>
                </c:pt>
                <c:pt idx="125">
                  <c:v>46.2271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188-9145-BEB1-7AFCF50599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361728"/>
        <c:axId val="186376576"/>
      </c:scatterChart>
      <c:valAx>
        <c:axId val="186361728"/>
        <c:scaling>
          <c:orientation val="minMax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 sz="1200" b="0" i="1"/>
                </a:pPr>
                <a:r>
                  <a:rPr lang="en-US" sz="1200" b="0" i="1"/>
                  <a:t>EGFR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b="0" i="0"/>
            </a:pPr>
            <a:endParaRPr lang="en-US"/>
          </a:p>
        </c:txPr>
        <c:crossAx val="186376576"/>
        <c:crosses val="autoZero"/>
        <c:crossBetween val="midCat"/>
      </c:valAx>
      <c:valAx>
        <c:axId val="1863765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 i="1"/>
                </a:pPr>
                <a:r>
                  <a:rPr lang="en-US" sz="1200" b="0" i="1"/>
                  <a:t>RHAMM</a:t>
                </a:r>
                <a:r>
                  <a:rPr lang="en-US" sz="1200" b="0" i="1" baseline="30000"/>
                  <a:t>A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b="0" i="0"/>
            </a:pPr>
            <a:endParaRPr lang="en-US"/>
          </a:p>
        </c:txPr>
        <c:crossAx val="186361728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98D967CC-F9ED-4EA5-B975-5E203D1364F7}" type="datetimeFigureOut">
              <a:rPr lang="en-US" smtClean="0"/>
              <a:t>4/1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818DE890-023C-4253-A8EB-668D45114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13064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3ADFBD5A-F892-CC49-AA0D-186EA178144F}" type="datetimeFigureOut">
              <a:rPr lang="en-US" smtClean="0"/>
              <a:t>4/13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6B7DEE2-34E5-4A4E-854C-0216CE9B3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9792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97100" y="696913"/>
            <a:ext cx="2616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B7DEE2-34E5-4A4E-854C-0216CE9B351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8105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BB0B-73E0-BE44-88C8-AEA710A760DC}" type="datetimeFigureOut">
              <a:rPr lang="en-US" smtClean="0"/>
              <a:t>4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3B7C-9FFC-F74E-BC89-9301A2009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340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BB0B-73E0-BE44-88C8-AEA710A760DC}" type="datetimeFigureOut">
              <a:rPr lang="en-US" smtClean="0"/>
              <a:t>4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3B7C-9FFC-F74E-BC89-9301A2009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8727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BB0B-73E0-BE44-88C8-AEA710A760DC}" type="datetimeFigureOut">
              <a:rPr lang="en-US" smtClean="0"/>
              <a:t>4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3B7C-9FFC-F74E-BC89-9301A2009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920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BB0B-73E0-BE44-88C8-AEA710A760DC}" type="datetimeFigureOut">
              <a:rPr lang="en-US" smtClean="0"/>
              <a:t>4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3B7C-9FFC-F74E-BC89-9301A2009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115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BB0B-73E0-BE44-88C8-AEA710A760DC}" type="datetimeFigureOut">
              <a:rPr lang="en-US" smtClean="0"/>
              <a:t>4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3B7C-9FFC-F74E-BC89-9301A2009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131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BB0B-73E0-BE44-88C8-AEA710A760DC}" type="datetimeFigureOut">
              <a:rPr lang="en-US" smtClean="0"/>
              <a:t>4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3B7C-9FFC-F74E-BC89-9301A2009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629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BB0B-73E0-BE44-88C8-AEA710A760DC}" type="datetimeFigureOut">
              <a:rPr lang="en-US" smtClean="0"/>
              <a:t>4/1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3B7C-9FFC-F74E-BC89-9301A2009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165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BB0B-73E0-BE44-88C8-AEA710A760DC}" type="datetimeFigureOut">
              <a:rPr lang="en-US" smtClean="0"/>
              <a:t>4/1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3B7C-9FFC-F74E-BC89-9301A2009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1745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BB0B-73E0-BE44-88C8-AEA710A760DC}" type="datetimeFigureOut">
              <a:rPr lang="en-US" smtClean="0"/>
              <a:t>4/1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3B7C-9FFC-F74E-BC89-9301A2009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1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BB0B-73E0-BE44-88C8-AEA710A760DC}" type="datetimeFigureOut">
              <a:rPr lang="en-US" smtClean="0"/>
              <a:t>4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3B7C-9FFC-F74E-BC89-9301A2009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5019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BB0B-73E0-BE44-88C8-AEA710A760DC}" type="datetimeFigureOut">
              <a:rPr lang="en-US" smtClean="0"/>
              <a:t>4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E3B7C-9FFC-F74E-BC89-9301A2009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841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7CBB0B-73E0-BE44-88C8-AEA710A760DC}" type="datetimeFigureOut">
              <a:rPr lang="en-US" smtClean="0"/>
              <a:t>4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2E3B7C-9FFC-F74E-BC89-9301A2009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7174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163752"/>
              </p:ext>
            </p:extLst>
          </p:nvPr>
        </p:nvGraphicFramePr>
        <p:xfrm>
          <a:off x="3561900" y="2004874"/>
          <a:ext cx="2971800" cy="22161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967016" y="2152694"/>
            <a:ext cx="740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Arial"/>
                <a:cs typeface="Arial"/>
              </a:rPr>
              <a:t>RHAMM</a:t>
            </a:r>
            <a:r>
              <a:rPr lang="en-US" sz="1000" i="1" baseline="30000" dirty="0">
                <a:latin typeface="Arial"/>
                <a:cs typeface="Arial"/>
              </a:rPr>
              <a:t>A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895621" y="4102616"/>
            <a:ext cx="2547746" cy="400111"/>
            <a:chOff x="762721" y="8671352"/>
            <a:chExt cx="2547746" cy="400109"/>
          </a:xfrm>
        </p:grpSpPr>
        <p:sp>
          <p:nvSpPr>
            <p:cNvPr id="8" name="TextBox 7"/>
            <p:cNvSpPr txBox="1"/>
            <p:nvPr/>
          </p:nvSpPr>
          <p:spPr>
            <a:xfrm>
              <a:off x="1005232" y="8671352"/>
              <a:ext cx="2305235" cy="400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          Primary                     </a:t>
              </a:r>
              <a:r>
                <a:rPr lang="en-US" sz="800" dirty="0">
                  <a:latin typeface="Arial"/>
                  <a:cs typeface="Arial"/>
                </a:rPr>
                <a:t> </a:t>
              </a:r>
              <a:r>
                <a:rPr lang="en-US" sz="1000" dirty="0">
                  <a:latin typeface="Arial"/>
                  <a:cs typeface="Arial"/>
                </a:rPr>
                <a:t>Liver met</a:t>
              </a:r>
            </a:p>
            <a:p>
              <a:r>
                <a:rPr lang="en-US" sz="1000" dirty="0">
                  <a:latin typeface="Arial"/>
                  <a:cs typeface="Arial"/>
                </a:rPr>
                <a:t>		</a:t>
              </a:r>
              <a:endParaRPr lang="en-US" sz="1100" dirty="0">
                <a:latin typeface="Arial"/>
                <a:cs typeface="Arial"/>
              </a:endParaRPr>
            </a:p>
          </p:txBody>
        </p:sp>
        <p:cxnSp>
          <p:nvCxnSpPr>
            <p:cNvPr id="9" name="Straight Connector 8"/>
            <p:cNvCxnSpPr/>
            <p:nvPr/>
          </p:nvCxnSpPr>
          <p:spPr>
            <a:xfrm>
              <a:off x="762721" y="8703532"/>
              <a:ext cx="178308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2635250" y="8703532"/>
              <a:ext cx="543589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8011931"/>
              </p:ext>
            </p:extLst>
          </p:nvPr>
        </p:nvGraphicFramePr>
        <p:xfrm>
          <a:off x="562666" y="2004874"/>
          <a:ext cx="2959100" cy="21907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4218024"/>
              </p:ext>
            </p:extLst>
          </p:nvPr>
        </p:nvGraphicFramePr>
        <p:xfrm>
          <a:off x="3561900" y="1994834"/>
          <a:ext cx="2971800" cy="22161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3985317" y="2152694"/>
            <a:ext cx="7438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latin typeface="Arial"/>
                <a:cs typeface="Arial"/>
              </a:rPr>
              <a:t>RHAMM</a:t>
            </a:r>
            <a:r>
              <a:rPr lang="en-US" sz="1000" i="1" baseline="30000" dirty="0">
                <a:latin typeface="Arial"/>
                <a:cs typeface="Arial"/>
              </a:rPr>
              <a:t>B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3908563" y="4102616"/>
            <a:ext cx="2547746" cy="400111"/>
            <a:chOff x="762721" y="8671352"/>
            <a:chExt cx="2547746" cy="400109"/>
          </a:xfrm>
        </p:grpSpPr>
        <p:sp>
          <p:nvSpPr>
            <p:cNvPr id="15" name="TextBox 14"/>
            <p:cNvSpPr txBox="1"/>
            <p:nvPr/>
          </p:nvSpPr>
          <p:spPr>
            <a:xfrm>
              <a:off x="1005232" y="8671352"/>
              <a:ext cx="2305235" cy="400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          Primary                     </a:t>
              </a:r>
              <a:r>
                <a:rPr lang="en-US" sz="800" dirty="0">
                  <a:latin typeface="Arial"/>
                  <a:cs typeface="Arial"/>
                </a:rPr>
                <a:t> </a:t>
              </a:r>
              <a:r>
                <a:rPr lang="en-US" sz="1000" dirty="0">
                  <a:latin typeface="Arial"/>
                  <a:cs typeface="Arial"/>
                </a:rPr>
                <a:t>Liver met</a:t>
              </a:r>
            </a:p>
            <a:p>
              <a:r>
                <a:rPr lang="en-US" sz="1000" dirty="0">
                  <a:latin typeface="Arial"/>
                  <a:cs typeface="Arial"/>
                </a:rPr>
                <a:t>		</a:t>
              </a:r>
              <a:endParaRPr lang="en-US" sz="1100" dirty="0">
                <a:latin typeface="Arial"/>
                <a:cs typeface="Arial"/>
              </a:endParaRPr>
            </a:p>
          </p:txBody>
        </p:sp>
        <p:cxnSp>
          <p:nvCxnSpPr>
            <p:cNvPr id="16" name="Straight Connector 15"/>
            <p:cNvCxnSpPr/>
            <p:nvPr/>
          </p:nvCxnSpPr>
          <p:spPr>
            <a:xfrm>
              <a:off x="762721" y="8703532"/>
              <a:ext cx="1783080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2635250" y="8703532"/>
              <a:ext cx="543589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" name="TextBox 17"/>
          <p:cNvSpPr txBox="1"/>
          <p:nvPr/>
        </p:nvSpPr>
        <p:spPr>
          <a:xfrm>
            <a:off x="291063" y="1686673"/>
            <a:ext cx="432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A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330780" y="1686673"/>
            <a:ext cx="432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B</a:t>
            </a:r>
          </a:p>
        </p:txBody>
      </p:sp>
      <p:sp>
        <p:nvSpPr>
          <p:cNvPr id="20" name="TextBox 19"/>
          <p:cNvSpPr txBox="1"/>
          <p:nvPr/>
        </p:nvSpPr>
        <p:spPr>
          <a:xfrm rot="16200000">
            <a:off x="-153886" y="2801083"/>
            <a:ext cx="13269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mRNA fold change </a:t>
            </a:r>
          </a:p>
        </p:txBody>
      </p:sp>
      <p:sp>
        <p:nvSpPr>
          <p:cNvPr id="21" name="TextBox 20"/>
          <p:cNvSpPr txBox="1"/>
          <p:nvPr/>
        </p:nvSpPr>
        <p:spPr>
          <a:xfrm rot="16200000">
            <a:off x="2869563" y="2801083"/>
            <a:ext cx="13269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mRNA fold change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566988" y="0"/>
            <a:ext cx="22910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charset="0"/>
                <a:ea typeface="Arial" charset="0"/>
                <a:cs typeface="Arial" charset="0"/>
              </a:rPr>
              <a:t>Additional file: Figure S1</a:t>
            </a:r>
            <a:endParaRPr lang="en-US" sz="1400" b="1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34431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/>
          <p:cNvSpPr txBox="1"/>
          <p:nvPr/>
        </p:nvSpPr>
        <p:spPr>
          <a:xfrm>
            <a:off x="1442118" y="868622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C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-44303" y="871598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A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-44001" y="381380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B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42" name="Rectangle 8"/>
          <p:cNvSpPr>
            <a:spLocks noChangeArrowheads="1"/>
          </p:cNvSpPr>
          <p:nvPr/>
        </p:nvSpPr>
        <p:spPr bwMode="auto">
          <a:xfrm>
            <a:off x="1041228" y="4018729"/>
            <a:ext cx="42414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zh-TW" sz="1200" b="1" dirty="0">
                <a:latin typeface="Arial" charset="0"/>
                <a:cs typeface="Arial" charset="0"/>
              </a:rPr>
              <a:t>ctrl</a:t>
            </a:r>
          </a:p>
        </p:txBody>
      </p:sp>
      <p:sp>
        <p:nvSpPr>
          <p:cNvPr id="58" name="Rectangle 57"/>
          <p:cNvSpPr/>
          <p:nvPr/>
        </p:nvSpPr>
        <p:spPr>
          <a:xfrm>
            <a:off x="1488331" y="868624"/>
            <a:ext cx="683701" cy="4953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9"/>
          <p:cNvSpPr>
            <a:spLocks noChangeArrowheads="1"/>
          </p:cNvSpPr>
          <p:nvPr/>
        </p:nvSpPr>
        <p:spPr bwMode="auto">
          <a:xfrm>
            <a:off x="5216572" y="4018729"/>
            <a:ext cx="85151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zh-TW" sz="1200" b="1" dirty="0">
                <a:latin typeface="Arial" charset="0"/>
                <a:cs typeface="Arial" charset="0"/>
              </a:rPr>
              <a:t>RHAMM</a:t>
            </a:r>
            <a:r>
              <a:rPr lang="en-US" altLang="zh-TW" sz="1200" b="1" baseline="30000" dirty="0">
                <a:latin typeface="Arial" charset="0"/>
                <a:cs typeface="Arial" charset="0"/>
              </a:rPr>
              <a:t>B</a:t>
            </a:r>
          </a:p>
        </p:txBody>
      </p:sp>
      <p:sp>
        <p:nvSpPr>
          <p:cNvPr id="47" name="Rectangle 9"/>
          <p:cNvSpPr>
            <a:spLocks noChangeArrowheads="1"/>
          </p:cNvSpPr>
          <p:nvPr/>
        </p:nvSpPr>
        <p:spPr bwMode="auto">
          <a:xfrm>
            <a:off x="3022056" y="4018729"/>
            <a:ext cx="85151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zh-TW" sz="1200" b="1" dirty="0">
                <a:latin typeface="Arial" charset="0"/>
                <a:cs typeface="Arial" charset="0"/>
              </a:rPr>
              <a:t>RHAMM</a:t>
            </a:r>
            <a:r>
              <a:rPr lang="en-US" altLang="zh-TW" sz="1200" b="1" baseline="30000" dirty="0">
                <a:latin typeface="Arial" charset="0"/>
                <a:cs typeface="Arial" charset="0"/>
              </a:rPr>
              <a:t>A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4566988" y="0"/>
            <a:ext cx="22910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charset="0"/>
                <a:ea typeface="Arial" charset="0"/>
                <a:cs typeface="Arial" charset="0"/>
              </a:rPr>
              <a:t>Additional file: Figure S2</a:t>
            </a:r>
            <a:endParaRPr 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531" y="1237954"/>
            <a:ext cx="3289300" cy="26035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8788" y="4257675"/>
            <a:ext cx="6440424" cy="1600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0227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Chart 43">
            <a:extLst>
              <a:ext uri="{FF2B5EF4-FFF2-40B4-BE49-F238E27FC236}">
                <a16:creationId xmlns="" xmlns:xdr="http://schemas.openxmlformats.org/drawingml/2006/spreadsheetDrawing" xmlns:a16="http://schemas.microsoft.com/office/drawing/2014/main" xmlns:lc="http://schemas.openxmlformats.org/drawingml/2006/lockedCanvas" id="{4C75191C-08A7-3B49-B50F-EBF6A7CD387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04286"/>
              </p:ext>
            </p:extLst>
          </p:nvPr>
        </p:nvGraphicFramePr>
        <p:xfrm>
          <a:off x="549764" y="3801147"/>
          <a:ext cx="4569883" cy="22838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8" name="Chart 47">
            <a:extLst>
              <a:ext uri="{FF2B5EF4-FFF2-40B4-BE49-F238E27FC236}">
                <a16:creationId xmlns="" xmlns:xdr="http://schemas.openxmlformats.org/drawingml/2006/spreadsheetDrawing" xmlns:a16="http://schemas.microsoft.com/office/drawing/2014/main" xmlns:lc="http://schemas.openxmlformats.org/drawingml/2006/lockedCanvas" id="{95E64D20-B93B-754B-9F5B-9FB4BD04FBD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55744778"/>
              </p:ext>
            </p:extLst>
          </p:nvPr>
        </p:nvGraphicFramePr>
        <p:xfrm>
          <a:off x="549764" y="1342223"/>
          <a:ext cx="457200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9" name="TextBox 48"/>
          <p:cNvSpPr txBox="1"/>
          <p:nvPr/>
        </p:nvSpPr>
        <p:spPr>
          <a:xfrm>
            <a:off x="235254" y="106187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A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35254" y="350413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B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4270173" y="4342293"/>
            <a:ext cx="3708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r = 0.45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4270173" y="1834805"/>
            <a:ext cx="3708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r = 0.1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566988" y="0"/>
            <a:ext cx="22910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charset="0"/>
                <a:ea typeface="Arial" charset="0"/>
                <a:cs typeface="Arial" charset="0"/>
              </a:rPr>
              <a:t>Additional file: Figure S3</a:t>
            </a:r>
            <a:endParaRPr lang="en-US" sz="1400" b="1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9292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393</TotalTime>
  <Words>52</Words>
  <Application>Microsoft Office PowerPoint</Application>
  <PresentationFormat>On-screen Show (4:3)</PresentationFormat>
  <Paragraphs>28</Paragraphs>
  <Slides>3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 Chieh Nancy Du</dc:creator>
  <cp:lastModifiedBy>JABELLA</cp:lastModifiedBy>
  <cp:revision>540</cp:revision>
  <cp:lastPrinted>2018-09-06T04:32:26Z</cp:lastPrinted>
  <dcterms:created xsi:type="dcterms:W3CDTF">2013-07-03T20:33:05Z</dcterms:created>
  <dcterms:modified xsi:type="dcterms:W3CDTF">2019-04-13T00:53:46Z</dcterms:modified>
</cp:coreProperties>
</file>